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9" r:id="rId2"/>
  </p:sldIdLst>
  <p:sldSz cx="109728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46"/>
    <p:restoredTop sz="94666"/>
  </p:normalViewPr>
  <p:slideViewPr>
    <p:cSldViewPr snapToGrid="0" snapToObjects="1">
      <p:cViewPr varScale="1">
        <p:scale>
          <a:sx n="104" d="100"/>
          <a:sy n="104" d="100"/>
        </p:scale>
        <p:origin x="72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1122363"/>
            <a:ext cx="8229600" cy="2387600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602038"/>
            <a:ext cx="8229600" cy="1655762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7160-DCF0-C94B-8DCA-C522EDEB51A0}" type="datetimeFigureOut">
              <a:rPr lang="en-US" smtClean="0"/>
              <a:t>9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FA71E-E6BA-EE46-8EEC-07DB2B3E87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99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7160-DCF0-C94B-8DCA-C522EDEB51A0}" type="datetimeFigureOut">
              <a:rPr lang="en-US" smtClean="0"/>
              <a:t>9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FA71E-E6BA-EE46-8EEC-07DB2B3E87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304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52410" y="365125"/>
            <a:ext cx="236601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4380" y="365125"/>
            <a:ext cx="696087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7160-DCF0-C94B-8DCA-C522EDEB51A0}" type="datetimeFigureOut">
              <a:rPr lang="en-US" smtClean="0"/>
              <a:t>9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FA71E-E6BA-EE46-8EEC-07DB2B3E87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6867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7160-DCF0-C94B-8DCA-C522EDEB51A0}" type="datetimeFigureOut">
              <a:rPr lang="en-US" smtClean="0"/>
              <a:t>9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FA71E-E6BA-EE46-8EEC-07DB2B3E87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9498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8665" y="1709739"/>
            <a:ext cx="9464040" cy="2852737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8665" y="4589464"/>
            <a:ext cx="9464040" cy="1500187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7160-DCF0-C94B-8DCA-C522EDEB51A0}" type="datetimeFigureOut">
              <a:rPr lang="en-US" smtClean="0"/>
              <a:t>9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FA71E-E6BA-EE46-8EEC-07DB2B3E87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908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4380" y="1825625"/>
            <a:ext cx="466344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54980" y="1825625"/>
            <a:ext cx="466344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7160-DCF0-C94B-8DCA-C522EDEB51A0}" type="datetimeFigureOut">
              <a:rPr lang="en-US" smtClean="0"/>
              <a:t>9/1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FA71E-E6BA-EE46-8EEC-07DB2B3E87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5917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365126"/>
            <a:ext cx="946404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5810" y="1681163"/>
            <a:ext cx="4642008" cy="823912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5810" y="2505075"/>
            <a:ext cx="464200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54980" y="1681163"/>
            <a:ext cx="4664869" cy="823912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54980" y="2505075"/>
            <a:ext cx="4664869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7160-DCF0-C94B-8DCA-C522EDEB51A0}" type="datetimeFigureOut">
              <a:rPr lang="en-US" smtClean="0"/>
              <a:t>9/10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FA71E-E6BA-EE46-8EEC-07DB2B3E87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111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7160-DCF0-C94B-8DCA-C522EDEB51A0}" type="datetimeFigureOut">
              <a:rPr lang="en-US" smtClean="0"/>
              <a:t>9/10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FA71E-E6BA-EE46-8EEC-07DB2B3E87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26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7160-DCF0-C94B-8DCA-C522EDEB51A0}" type="datetimeFigureOut">
              <a:rPr lang="en-US" smtClean="0"/>
              <a:t>9/10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FA71E-E6BA-EE46-8EEC-07DB2B3E87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867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10" y="457200"/>
            <a:ext cx="3539013" cy="160020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64869" y="987426"/>
            <a:ext cx="5554980" cy="4873625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10" y="2057400"/>
            <a:ext cx="3539013" cy="3811588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7160-DCF0-C94B-8DCA-C522EDEB51A0}" type="datetimeFigureOut">
              <a:rPr lang="en-US" smtClean="0"/>
              <a:t>9/1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FA71E-E6BA-EE46-8EEC-07DB2B3E87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552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10" y="457200"/>
            <a:ext cx="3539013" cy="160020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64869" y="987426"/>
            <a:ext cx="5554980" cy="4873625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10" y="2057400"/>
            <a:ext cx="3539013" cy="3811588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7160-DCF0-C94B-8DCA-C522EDEB51A0}" type="datetimeFigureOut">
              <a:rPr lang="en-US" smtClean="0"/>
              <a:t>9/1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FA71E-E6BA-EE46-8EEC-07DB2B3E87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605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4380" y="365126"/>
            <a:ext cx="946404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380" y="1825625"/>
            <a:ext cx="946404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4380" y="6356351"/>
            <a:ext cx="24688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D7160-DCF0-C94B-8DCA-C522EDEB51A0}" type="datetimeFigureOut">
              <a:rPr lang="en-US" smtClean="0"/>
              <a:t>9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34740" y="6356351"/>
            <a:ext cx="37033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49540" y="6356351"/>
            <a:ext cx="24688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FA71E-E6BA-EE46-8EEC-07DB2B3E87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205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TextBox 62">
            <a:extLst>
              <a:ext uri="{FF2B5EF4-FFF2-40B4-BE49-F238E27FC236}">
                <a16:creationId xmlns:a16="http://schemas.microsoft.com/office/drawing/2014/main" id="{A96ECBF9-0C76-8245-8E09-9C6C92345849}"/>
              </a:ext>
            </a:extLst>
          </p:cNvPr>
          <p:cNvSpPr txBox="1"/>
          <p:nvPr/>
        </p:nvSpPr>
        <p:spPr>
          <a:xfrm>
            <a:off x="0" y="0"/>
            <a:ext cx="9973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C568A8E-F771-694A-B43A-4412BFC5AF71}"/>
              </a:ext>
            </a:extLst>
          </p:cNvPr>
          <p:cNvSpPr txBox="1"/>
          <p:nvPr/>
        </p:nvSpPr>
        <p:spPr>
          <a:xfrm>
            <a:off x="20906" y="44854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1A728FC-BE63-1249-B116-9C82FE049F9D}"/>
              </a:ext>
            </a:extLst>
          </p:cNvPr>
          <p:cNvSpPr txBox="1"/>
          <p:nvPr/>
        </p:nvSpPr>
        <p:spPr>
          <a:xfrm>
            <a:off x="51274" y="342027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id="{7F0B5C15-60D4-B641-B8FB-32D97F46D3E9}"/>
              </a:ext>
            </a:extLst>
          </p:cNvPr>
          <p:cNvGrpSpPr/>
          <p:nvPr/>
        </p:nvGrpSpPr>
        <p:grpSpPr>
          <a:xfrm>
            <a:off x="5164760" y="3971368"/>
            <a:ext cx="5008955" cy="2308316"/>
            <a:chOff x="1742476" y="3412141"/>
            <a:chExt cx="5008955" cy="2308316"/>
          </a:xfrm>
        </p:grpSpPr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2732C525-80BB-BF4C-BB38-39C44F192F8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41703" y="3740521"/>
              <a:ext cx="1593007" cy="1593007"/>
            </a:xfrm>
            <a:prstGeom prst="rect">
              <a:avLst/>
            </a:prstGeom>
          </p:spPr>
        </p:pic>
        <p:pic>
          <p:nvPicPr>
            <p:cNvPr id="81" name="Picture 80">
              <a:extLst>
                <a:ext uri="{FF2B5EF4-FFF2-40B4-BE49-F238E27FC236}">
                  <a16:creationId xmlns:a16="http://schemas.microsoft.com/office/drawing/2014/main" id="{9ED8797E-27AF-7D4D-ABA4-55AABA2E199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149676" y="3731773"/>
              <a:ext cx="1601755" cy="1601755"/>
            </a:xfrm>
            <a:prstGeom prst="rect">
              <a:avLst/>
            </a:prstGeom>
          </p:spPr>
        </p:pic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4D3748D0-C913-7C4A-B5C3-3CDD977FE880}"/>
                </a:ext>
              </a:extLst>
            </p:cNvPr>
            <p:cNvSpPr txBox="1"/>
            <p:nvPr/>
          </p:nvSpPr>
          <p:spPr>
            <a:xfrm>
              <a:off x="3241110" y="5381903"/>
              <a:ext cx="259064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SC</a:t>
              </a:r>
              <a:r>
                <a: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hBAK+MCL1 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+ A549</a:t>
              </a:r>
              <a:r>
                <a: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4+9b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24200FC3-3B91-1846-8242-E28939ECCF26}"/>
                </a:ext>
              </a:extLst>
            </p:cNvPr>
            <p:cNvSpPr txBox="1"/>
            <p:nvPr/>
          </p:nvSpPr>
          <p:spPr>
            <a:xfrm>
              <a:off x="2197502" y="3412141"/>
              <a:ext cx="7665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rge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0D3A5E87-0264-5C49-B49C-571AD53A627E}"/>
                </a:ext>
              </a:extLst>
            </p:cNvPr>
            <p:cNvSpPr txBox="1"/>
            <p:nvPr/>
          </p:nvSpPr>
          <p:spPr>
            <a:xfrm>
              <a:off x="3781762" y="3422647"/>
              <a:ext cx="99418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GFP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3F7B57BD-CDDB-FE43-AD68-308E4BD81661}"/>
                </a:ext>
              </a:extLst>
            </p:cNvPr>
            <p:cNvSpPr txBox="1"/>
            <p:nvPr/>
          </p:nvSpPr>
          <p:spPr>
            <a:xfrm>
              <a:off x="5484726" y="3436448"/>
              <a:ext cx="7521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DR</a:t>
              </a:r>
            </a:p>
          </p:txBody>
        </p: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AB37CF8A-85B0-AA40-AEB6-F5C1929277EA}"/>
                </a:ext>
              </a:extLst>
            </p:cNvPr>
            <p:cNvGrpSpPr/>
            <p:nvPr/>
          </p:nvGrpSpPr>
          <p:grpSpPr>
            <a:xfrm>
              <a:off x="1742476" y="3731773"/>
              <a:ext cx="1584260" cy="1584260"/>
              <a:chOff x="4133728" y="608361"/>
              <a:chExt cx="1584260" cy="1584260"/>
            </a:xfrm>
          </p:grpSpPr>
          <p:pic>
            <p:nvPicPr>
              <p:cNvPr id="90" name="Picture 89">
                <a:extLst>
                  <a:ext uri="{FF2B5EF4-FFF2-40B4-BE49-F238E27FC236}">
                    <a16:creationId xmlns:a16="http://schemas.microsoft.com/office/drawing/2014/main" id="{3A00E3FC-D441-2041-B3EB-0C62D82A2D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133728" y="608361"/>
                <a:ext cx="1584260" cy="1584260"/>
              </a:xfrm>
              <a:prstGeom prst="rect">
                <a:avLst/>
              </a:prstGeom>
            </p:spPr>
          </p:pic>
          <p:cxnSp>
            <p:nvCxnSpPr>
              <p:cNvPr id="91" name="Straight Connector 90">
                <a:extLst>
                  <a:ext uri="{FF2B5EF4-FFF2-40B4-BE49-F238E27FC236}">
                    <a16:creationId xmlns:a16="http://schemas.microsoft.com/office/drawing/2014/main" id="{21A33893-4327-9B47-933F-1574196D490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37907" y="2128783"/>
                <a:ext cx="432238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92" name="TextBox 91">
            <a:extLst>
              <a:ext uri="{FF2B5EF4-FFF2-40B4-BE49-F238E27FC236}">
                <a16:creationId xmlns:a16="http://schemas.microsoft.com/office/drawing/2014/main" id="{621E48D2-0DAE-124C-BA50-1747ABA59588}"/>
              </a:ext>
            </a:extLst>
          </p:cNvPr>
          <p:cNvSpPr txBox="1"/>
          <p:nvPr/>
        </p:nvSpPr>
        <p:spPr>
          <a:xfrm>
            <a:off x="4835284" y="3968809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93" name="Group 92">
            <a:extLst>
              <a:ext uri="{FF2B5EF4-FFF2-40B4-BE49-F238E27FC236}">
                <a16:creationId xmlns:a16="http://schemas.microsoft.com/office/drawing/2014/main" id="{43EA90C5-AC31-5D43-92D1-AF9A9CDBFEB8}"/>
              </a:ext>
            </a:extLst>
          </p:cNvPr>
          <p:cNvGrpSpPr/>
          <p:nvPr/>
        </p:nvGrpSpPr>
        <p:grpSpPr>
          <a:xfrm>
            <a:off x="4365087" y="502416"/>
            <a:ext cx="2970045" cy="3272214"/>
            <a:chOff x="2721638" y="488403"/>
            <a:chExt cx="2970045" cy="3272214"/>
          </a:xfrm>
        </p:grpSpPr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B88895BC-28D2-374D-B32E-F3299AFEDB2E}"/>
                </a:ext>
              </a:extLst>
            </p:cNvPr>
            <p:cNvGrpSpPr/>
            <p:nvPr/>
          </p:nvGrpSpPr>
          <p:grpSpPr>
            <a:xfrm>
              <a:off x="2721638" y="488403"/>
              <a:ext cx="2970045" cy="3272214"/>
              <a:chOff x="2588181" y="461903"/>
              <a:chExt cx="2970045" cy="3272214"/>
            </a:xfrm>
          </p:grpSpPr>
          <p:pic>
            <p:nvPicPr>
              <p:cNvPr id="97" name="Picture 96">
                <a:extLst>
                  <a:ext uri="{FF2B5EF4-FFF2-40B4-BE49-F238E27FC236}">
                    <a16:creationId xmlns:a16="http://schemas.microsoft.com/office/drawing/2014/main" id="{FCB2EB85-BCFB-2B49-9298-9E781001CC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20777" t="14053" r="35868" b="46668"/>
              <a:stretch/>
            </p:blipFill>
            <p:spPr>
              <a:xfrm>
                <a:off x="3009139" y="721214"/>
                <a:ext cx="2236574" cy="2693773"/>
              </a:xfrm>
              <a:prstGeom prst="rect">
                <a:avLst/>
              </a:prstGeom>
            </p:spPr>
          </p:pic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DCD429A9-A3CF-EE42-8A33-9B839AE2BD3C}"/>
                  </a:ext>
                </a:extLst>
              </p:cNvPr>
              <p:cNvSpPr txBox="1"/>
              <p:nvPr/>
            </p:nvSpPr>
            <p:spPr>
              <a:xfrm>
                <a:off x="3001536" y="466969"/>
                <a:ext cx="88998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SC</a:t>
                </a:r>
                <a:r>
                  <a:rPr lang="en-US" sz="1600" baseline="300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  <a:endParaRPr lang="en-US" sz="1600" baseline="30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4B38A797-4CB7-5E4A-97BF-A838CB537863}"/>
                  </a:ext>
                </a:extLst>
              </p:cNvPr>
              <p:cNvSpPr txBox="1"/>
              <p:nvPr/>
            </p:nvSpPr>
            <p:spPr>
              <a:xfrm>
                <a:off x="3851085" y="461903"/>
                <a:ext cx="150233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SC</a:t>
                </a:r>
                <a:r>
                  <a:rPr lang="en-US" sz="1600" baseline="300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hBAK+MCL1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A182156E-144E-0847-A0E1-2E8ECB9E3EA9}"/>
                  </a:ext>
                </a:extLst>
              </p:cNvPr>
              <p:cNvSpPr txBox="1"/>
              <p:nvPr/>
            </p:nvSpPr>
            <p:spPr>
              <a:xfrm rot="16200000">
                <a:off x="5035326" y="1628482"/>
                <a:ext cx="70724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CD45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699BF587-8E1F-E843-A590-E1286A043F0D}"/>
                  </a:ext>
                </a:extLst>
              </p:cNvPr>
              <p:cNvSpPr txBox="1"/>
              <p:nvPr/>
            </p:nvSpPr>
            <p:spPr>
              <a:xfrm rot="16200000">
                <a:off x="5035326" y="2540256"/>
                <a:ext cx="70724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CD44</a:t>
                </a:r>
              </a:p>
            </p:txBody>
          </p:sp>
          <p:grpSp>
            <p:nvGrpSpPr>
              <p:cNvPr id="102" name="Group 101">
                <a:extLst>
                  <a:ext uri="{FF2B5EF4-FFF2-40B4-BE49-F238E27FC236}">
                    <a16:creationId xmlns:a16="http://schemas.microsoft.com/office/drawing/2014/main" id="{4FA1EF1F-28C0-C048-8499-8988E90C7463}"/>
                  </a:ext>
                </a:extLst>
              </p:cNvPr>
              <p:cNvGrpSpPr/>
              <p:nvPr/>
            </p:nvGrpSpPr>
            <p:grpSpPr>
              <a:xfrm>
                <a:off x="4271755" y="900843"/>
                <a:ext cx="914400" cy="2243801"/>
                <a:chOff x="4271755" y="900843"/>
                <a:chExt cx="914400" cy="2243801"/>
              </a:xfrm>
            </p:grpSpPr>
            <p:cxnSp>
              <p:nvCxnSpPr>
                <p:cNvPr id="112" name="Straight Connector 111">
                  <a:extLst>
                    <a:ext uri="{FF2B5EF4-FFF2-40B4-BE49-F238E27FC236}">
                      <a16:creationId xmlns:a16="http://schemas.microsoft.com/office/drawing/2014/main" id="{E3BD1F86-2EA2-9F49-BF43-B9E1D889821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71755" y="907622"/>
                  <a:ext cx="9144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Straight Connector 112">
                  <a:extLst>
                    <a:ext uri="{FF2B5EF4-FFF2-40B4-BE49-F238E27FC236}">
                      <a16:creationId xmlns:a16="http://schemas.microsoft.com/office/drawing/2014/main" id="{2FD94DAF-3F22-0C4A-9A60-5DFB7EAD8E9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276254" y="900843"/>
                  <a:ext cx="1" cy="2243801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4F928237-264E-6140-A0AC-5CC4FE223C56}"/>
                  </a:ext>
                </a:extLst>
              </p:cNvPr>
              <p:cNvSpPr txBox="1"/>
              <p:nvPr/>
            </p:nvSpPr>
            <p:spPr>
              <a:xfrm>
                <a:off x="4526258" y="2683749"/>
                <a:ext cx="76655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96.3%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23CA8D32-43DC-0F41-99D6-A520E372CA59}"/>
                  </a:ext>
                </a:extLst>
              </p:cNvPr>
              <p:cNvSpPr txBox="1"/>
              <p:nvPr/>
            </p:nvSpPr>
            <p:spPr>
              <a:xfrm>
                <a:off x="4503210" y="2220425"/>
                <a:ext cx="76655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94.1%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0FBFF98F-3ECF-3149-A644-E2291BD974A7}"/>
                  </a:ext>
                </a:extLst>
              </p:cNvPr>
              <p:cNvSpPr txBox="1"/>
              <p:nvPr/>
            </p:nvSpPr>
            <p:spPr>
              <a:xfrm>
                <a:off x="4540561" y="1105193"/>
                <a:ext cx="65274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2.3%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8B40AD5E-113F-5F47-9198-21B71E728D56}"/>
                  </a:ext>
                </a:extLst>
              </p:cNvPr>
              <p:cNvSpPr txBox="1"/>
              <p:nvPr/>
            </p:nvSpPr>
            <p:spPr>
              <a:xfrm>
                <a:off x="4483655" y="1754749"/>
                <a:ext cx="76655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.98%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7698DE55-1C6C-3F46-BA58-A680E53334D7}"/>
                  </a:ext>
                </a:extLst>
              </p:cNvPr>
              <p:cNvSpPr txBox="1"/>
              <p:nvPr/>
            </p:nvSpPr>
            <p:spPr>
              <a:xfrm>
                <a:off x="3189247" y="3395563"/>
                <a:ext cx="63991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FITC</a:t>
                </a:r>
              </a:p>
            </p:txBody>
          </p:sp>
          <p:grpSp>
            <p:nvGrpSpPr>
              <p:cNvPr id="108" name="Group 107">
                <a:extLst>
                  <a:ext uri="{FF2B5EF4-FFF2-40B4-BE49-F238E27FC236}">
                    <a16:creationId xmlns:a16="http://schemas.microsoft.com/office/drawing/2014/main" id="{29F8DCF6-9BF5-394F-889B-CB88F1F812A2}"/>
                  </a:ext>
                </a:extLst>
              </p:cNvPr>
              <p:cNvGrpSpPr/>
              <p:nvPr/>
            </p:nvGrpSpPr>
            <p:grpSpPr>
              <a:xfrm>
                <a:off x="2921228" y="2363165"/>
                <a:ext cx="1174377" cy="1078326"/>
                <a:chOff x="2801960" y="2349913"/>
                <a:chExt cx="1174377" cy="1078326"/>
              </a:xfrm>
            </p:grpSpPr>
            <p:cxnSp>
              <p:nvCxnSpPr>
                <p:cNvPr id="110" name="Straight Connector 109">
                  <a:extLst>
                    <a:ext uri="{FF2B5EF4-FFF2-40B4-BE49-F238E27FC236}">
                      <a16:creationId xmlns:a16="http://schemas.microsoft.com/office/drawing/2014/main" id="{DC8450A3-C1D2-5A42-A7DA-27020C51888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01960" y="3428239"/>
                  <a:ext cx="117437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Straight Connector 110">
                  <a:extLst>
                    <a:ext uri="{FF2B5EF4-FFF2-40B4-BE49-F238E27FC236}">
                      <a16:creationId xmlns:a16="http://schemas.microsoft.com/office/drawing/2014/main" id="{23168FEE-300B-5544-9614-EDE637604F8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01960" y="2349913"/>
                  <a:ext cx="0" cy="107683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02EF6605-8721-AF4C-A4A0-E476573799FA}"/>
                  </a:ext>
                </a:extLst>
              </p:cNvPr>
              <p:cNvSpPr txBox="1"/>
              <p:nvPr/>
            </p:nvSpPr>
            <p:spPr>
              <a:xfrm rot="16200000">
                <a:off x="2414255" y="2842797"/>
                <a:ext cx="6864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count</a:t>
                </a:r>
              </a:p>
            </p:txBody>
          </p:sp>
        </p:grp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8D937DD8-BC1B-D141-9E6E-C04577EFBEBA}"/>
                </a:ext>
              </a:extLst>
            </p:cNvPr>
            <p:cNvCxnSpPr>
              <a:cxnSpLocks/>
            </p:cNvCxnSpPr>
            <p:nvPr/>
          </p:nvCxnSpPr>
          <p:spPr>
            <a:xfrm>
              <a:off x="5378134" y="1432096"/>
              <a:ext cx="1036" cy="7496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EF44CEFB-AE93-A744-808E-DC59FD74A39F}"/>
                </a:ext>
              </a:extLst>
            </p:cNvPr>
            <p:cNvCxnSpPr>
              <a:cxnSpLocks/>
            </p:cNvCxnSpPr>
            <p:nvPr/>
          </p:nvCxnSpPr>
          <p:spPr>
            <a:xfrm>
              <a:off x="5384772" y="2320536"/>
              <a:ext cx="1036" cy="7496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4" name="Group 113">
            <a:extLst>
              <a:ext uri="{FF2B5EF4-FFF2-40B4-BE49-F238E27FC236}">
                <a16:creationId xmlns:a16="http://schemas.microsoft.com/office/drawing/2014/main" id="{F743B135-87F3-064D-AD78-887E6AC71C4F}"/>
              </a:ext>
            </a:extLst>
          </p:cNvPr>
          <p:cNvGrpSpPr/>
          <p:nvPr/>
        </p:nvGrpSpPr>
        <p:grpSpPr>
          <a:xfrm>
            <a:off x="7425244" y="518065"/>
            <a:ext cx="3193591" cy="3268463"/>
            <a:chOff x="5781795" y="504052"/>
            <a:chExt cx="3193591" cy="3268463"/>
          </a:xfrm>
        </p:grpSpPr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ADB2EECC-7701-E949-91D6-8C13E9F9B3A8}"/>
                </a:ext>
              </a:extLst>
            </p:cNvPr>
            <p:cNvGrpSpPr/>
            <p:nvPr/>
          </p:nvGrpSpPr>
          <p:grpSpPr>
            <a:xfrm>
              <a:off x="5781795" y="504052"/>
              <a:ext cx="3193591" cy="3268463"/>
              <a:chOff x="5461688" y="485078"/>
              <a:chExt cx="3193591" cy="3268463"/>
            </a:xfrm>
          </p:grpSpPr>
          <p:pic>
            <p:nvPicPr>
              <p:cNvPr id="118" name="Picture 117">
                <a:extLst>
                  <a:ext uri="{FF2B5EF4-FFF2-40B4-BE49-F238E27FC236}">
                    <a16:creationId xmlns:a16="http://schemas.microsoft.com/office/drawing/2014/main" id="{A650C6A8-87AB-8840-961D-B1E9A930A85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20777" t="14054" r="34909" b="49730"/>
              <a:stretch/>
            </p:blipFill>
            <p:spPr>
              <a:xfrm>
                <a:off x="5889648" y="738861"/>
                <a:ext cx="2445223" cy="2656702"/>
              </a:xfrm>
              <a:prstGeom prst="rect">
                <a:avLst/>
              </a:prstGeom>
            </p:spPr>
          </p:pic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AA0AD2A3-8194-AD40-8A33-093C1605C074}"/>
                  </a:ext>
                </a:extLst>
              </p:cNvPr>
              <p:cNvSpPr txBox="1"/>
              <p:nvPr/>
            </p:nvSpPr>
            <p:spPr>
              <a:xfrm rot="16200000">
                <a:off x="8171653" y="1583597"/>
                <a:ext cx="62869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CD73</a:t>
                </a: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26A15101-6628-7046-B66A-77DC00D261AD}"/>
                  </a:ext>
                </a:extLst>
              </p:cNvPr>
              <p:cNvSpPr txBox="1"/>
              <p:nvPr/>
            </p:nvSpPr>
            <p:spPr>
              <a:xfrm rot="16200000">
                <a:off x="8171653" y="2500396"/>
                <a:ext cx="62869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CD90</a:t>
                </a:r>
              </a:p>
            </p:txBody>
          </p:sp>
          <p:grpSp>
            <p:nvGrpSpPr>
              <p:cNvPr id="121" name="Group 120">
                <a:extLst>
                  <a:ext uri="{FF2B5EF4-FFF2-40B4-BE49-F238E27FC236}">
                    <a16:creationId xmlns:a16="http://schemas.microsoft.com/office/drawing/2014/main" id="{22F246F4-97B7-B748-BECF-5FB271D1D2D4}"/>
                  </a:ext>
                </a:extLst>
              </p:cNvPr>
              <p:cNvGrpSpPr/>
              <p:nvPr/>
            </p:nvGrpSpPr>
            <p:grpSpPr>
              <a:xfrm>
                <a:off x="6820153" y="892632"/>
                <a:ext cx="1459627" cy="2243801"/>
                <a:chOff x="4271755" y="900843"/>
                <a:chExt cx="1459627" cy="2243801"/>
              </a:xfrm>
            </p:grpSpPr>
            <p:cxnSp>
              <p:nvCxnSpPr>
                <p:cNvPr id="133" name="Straight Connector 132">
                  <a:extLst>
                    <a:ext uri="{FF2B5EF4-FFF2-40B4-BE49-F238E27FC236}">
                      <a16:creationId xmlns:a16="http://schemas.microsoft.com/office/drawing/2014/main" id="{3514A240-40DA-6B40-9B45-B1EAEAEB06C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271755" y="900843"/>
                  <a:ext cx="1459627" cy="6779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4" name="Straight Connector 133">
                  <a:extLst>
                    <a:ext uri="{FF2B5EF4-FFF2-40B4-BE49-F238E27FC236}">
                      <a16:creationId xmlns:a16="http://schemas.microsoft.com/office/drawing/2014/main" id="{CFCA5265-2732-AF4C-98A9-B7B95CD8744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276254" y="900843"/>
                  <a:ext cx="1" cy="2243801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44F24118-B151-8143-8A93-B0C092F4FB26}"/>
                  </a:ext>
                </a:extLst>
              </p:cNvPr>
              <p:cNvSpPr txBox="1"/>
              <p:nvPr/>
            </p:nvSpPr>
            <p:spPr>
              <a:xfrm>
                <a:off x="7493403" y="1032345"/>
                <a:ext cx="76655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97.4%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03F83B2E-1510-BB42-8776-17CC273FCD08}"/>
                  </a:ext>
                </a:extLst>
              </p:cNvPr>
              <p:cNvSpPr txBox="1"/>
              <p:nvPr/>
            </p:nvSpPr>
            <p:spPr>
              <a:xfrm>
                <a:off x="7542258" y="1797759"/>
                <a:ext cx="76655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96.3%</a:t>
                </a: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FF36F17F-B798-3B40-AC48-9FA13FB7F21C}"/>
                  </a:ext>
                </a:extLst>
              </p:cNvPr>
              <p:cNvSpPr txBox="1"/>
              <p:nvPr/>
            </p:nvSpPr>
            <p:spPr>
              <a:xfrm>
                <a:off x="7586962" y="2300025"/>
                <a:ext cx="76655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98.1%</a:t>
                </a: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599E3339-DD0A-2F40-B4D8-BE752A714C5E}"/>
                  </a:ext>
                </a:extLst>
              </p:cNvPr>
              <p:cNvSpPr txBox="1"/>
              <p:nvPr/>
            </p:nvSpPr>
            <p:spPr>
              <a:xfrm>
                <a:off x="7586962" y="2802291"/>
                <a:ext cx="76655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98.7%</a:t>
                </a: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6ACAF88A-B356-A94A-B504-172BB2001C60}"/>
                  </a:ext>
                </a:extLst>
              </p:cNvPr>
              <p:cNvSpPr txBox="1"/>
              <p:nvPr/>
            </p:nvSpPr>
            <p:spPr>
              <a:xfrm>
                <a:off x="5883193" y="490144"/>
                <a:ext cx="88998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SC</a:t>
                </a:r>
                <a:r>
                  <a:rPr lang="en-US" sz="1600" baseline="300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  <a:endParaRPr lang="en-US" sz="1600" baseline="30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5F113E3B-2F32-9A40-A606-D8A2E885DDCA}"/>
                  </a:ext>
                </a:extLst>
              </p:cNvPr>
              <p:cNvSpPr txBox="1"/>
              <p:nvPr/>
            </p:nvSpPr>
            <p:spPr>
              <a:xfrm>
                <a:off x="6732742" y="485078"/>
                <a:ext cx="150233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SC</a:t>
                </a:r>
                <a:r>
                  <a:rPr lang="en-US" sz="1600" baseline="300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hBAK+MCL1</a:t>
                </a: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F8026695-9A44-2C45-8B51-A9468A9B5221}"/>
                  </a:ext>
                </a:extLst>
              </p:cNvPr>
              <p:cNvSpPr txBox="1"/>
              <p:nvPr/>
            </p:nvSpPr>
            <p:spPr>
              <a:xfrm>
                <a:off x="6153335" y="3414987"/>
                <a:ext cx="45717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PE</a:t>
                </a:r>
              </a:p>
            </p:txBody>
          </p:sp>
          <p:grpSp>
            <p:nvGrpSpPr>
              <p:cNvPr id="129" name="Group 128">
                <a:extLst>
                  <a:ext uri="{FF2B5EF4-FFF2-40B4-BE49-F238E27FC236}">
                    <a16:creationId xmlns:a16="http://schemas.microsoft.com/office/drawing/2014/main" id="{C27FCD9E-AFB7-B44B-9EE2-F374EE004F17}"/>
                  </a:ext>
                </a:extLst>
              </p:cNvPr>
              <p:cNvGrpSpPr/>
              <p:nvPr/>
            </p:nvGrpSpPr>
            <p:grpSpPr>
              <a:xfrm>
                <a:off x="5794735" y="2329594"/>
                <a:ext cx="1174377" cy="1078326"/>
                <a:chOff x="2801960" y="2349913"/>
                <a:chExt cx="1174377" cy="1078326"/>
              </a:xfrm>
            </p:grpSpPr>
            <p:cxnSp>
              <p:nvCxnSpPr>
                <p:cNvPr id="131" name="Straight Connector 130">
                  <a:extLst>
                    <a:ext uri="{FF2B5EF4-FFF2-40B4-BE49-F238E27FC236}">
                      <a16:creationId xmlns:a16="http://schemas.microsoft.com/office/drawing/2014/main" id="{70ADE855-E310-6942-9051-8C63FB1F9E4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01960" y="3428239"/>
                  <a:ext cx="117437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Straight Connector 131">
                  <a:extLst>
                    <a:ext uri="{FF2B5EF4-FFF2-40B4-BE49-F238E27FC236}">
                      <a16:creationId xmlns:a16="http://schemas.microsoft.com/office/drawing/2014/main" id="{F0C9FD4B-B38D-9449-B008-4C577272DC8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01960" y="2349913"/>
                  <a:ext cx="0" cy="107683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D9986993-5F77-0543-A7A8-AECDBA0C03D9}"/>
                  </a:ext>
                </a:extLst>
              </p:cNvPr>
              <p:cNvSpPr txBox="1"/>
              <p:nvPr/>
            </p:nvSpPr>
            <p:spPr>
              <a:xfrm rot="16200000">
                <a:off x="5287762" y="2809226"/>
                <a:ext cx="6864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count</a:t>
                </a:r>
              </a:p>
            </p:txBody>
          </p:sp>
        </p:grp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BEB69A19-9237-A644-BFE5-9BBB8CAF009B}"/>
                </a:ext>
              </a:extLst>
            </p:cNvPr>
            <p:cNvCxnSpPr>
              <a:cxnSpLocks/>
            </p:cNvCxnSpPr>
            <p:nvPr/>
          </p:nvCxnSpPr>
          <p:spPr>
            <a:xfrm>
              <a:off x="8671488" y="1445379"/>
              <a:ext cx="1036" cy="7496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id="{120B83EC-B1BA-7841-80E6-6E8B1E2F2B95}"/>
                </a:ext>
              </a:extLst>
            </p:cNvPr>
            <p:cNvCxnSpPr>
              <a:cxnSpLocks/>
            </p:cNvCxnSpPr>
            <p:nvPr/>
          </p:nvCxnSpPr>
          <p:spPr>
            <a:xfrm>
              <a:off x="8678126" y="2333819"/>
              <a:ext cx="1036" cy="7496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5" name="TextBox 134">
            <a:extLst>
              <a:ext uri="{FF2B5EF4-FFF2-40B4-BE49-F238E27FC236}">
                <a16:creationId xmlns:a16="http://schemas.microsoft.com/office/drawing/2014/main" id="{22C9A962-70F0-A14B-9E3F-10F4D85A5893}"/>
              </a:ext>
            </a:extLst>
          </p:cNvPr>
          <p:cNvSpPr txBox="1"/>
          <p:nvPr/>
        </p:nvSpPr>
        <p:spPr>
          <a:xfrm>
            <a:off x="4429650" y="42648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36" name="Picture 135">
            <a:extLst>
              <a:ext uri="{FF2B5EF4-FFF2-40B4-BE49-F238E27FC236}">
                <a16:creationId xmlns:a16="http://schemas.microsoft.com/office/drawing/2014/main" id="{D81091B2-61CA-0F49-B306-615BD553623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8747" y="3789609"/>
            <a:ext cx="1455380" cy="2164786"/>
          </a:xfrm>
          <a:prstGeom prst="rect">
            <a:avLst/>
          </a:prstGeom>
        </p:spPr>
      </p:pic>
      <p:pic>
        <p:nvPicPr>
          <p:cNvPr id="137" name="Picture 136">
            <a:extLst>
              <a:ext uri="{FF2B5EF4-FFF2-40B4-BE49-F238E27FC236}">
                <a16:creationId xmlns:a16="http://schemas.microsoft.com/office/drawing/2014/main" id="{993A7243-8DD5-9540-859A-F976C28B2A7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9219" y="738408"/>
            <a:ext cx="1680693" cy="236479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9573770-3E3C-B444-950D-42506B2E510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90908" y="720322"/>
            <a:ext cx="1684013" cy="236389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9EFB0F8-163C-7D41-A177-DF86B18391F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90908" y="3796569"/>
            <a:ext cx="1486164" cy="2165029"/>
          </a:xfrm>
          <a:prstGeom prst="rect">
            <a:avLst/>
          </a:prstGeom>
        </p:spPr>
      </p:pic>
      <p:sp>
        <p:nvSpPr>
          <p:cNvPr id="138" name="TextBox 137">
            <a:extLst>
              <a:ext uri="{FF2B5EF4-FFF2-40B4-BE49-F238E27FC236}">
                <a16:creationId xmlns:a16="http://schemas.microsoft.com/office/drawing/2014/main" id="{41B3F9DC-8F7E-5440-910D-82B1B03302F3}"/>
              </a:ext>
            </a:extLst>
          </p:cNvPr>
          <p:cNvSpPr txBox="1"/>
          <p:nvPr/>
        </p:nvSpPr>
        <p:spPr>
          <a:xfrm>
            <a:off x="2076367" y="44854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F73B0FF0-A2F3-4A42-A0D9-ED0732BE65F0}"/>
              </a:ext>
            </a:extLst>
          </p:cNvPr>
          <p:cNvSpPr txBox="1"/>
          <p:nvPr/>
        </p:nvSpPr>
        <p:spPr>
          <a:xfrm>
            <a:off x="2187315" y="34555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674453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70</TotalTime>
  <Words>49</Words>
  <Application>Microsoft Macintosh PowerPoint</Application>
  <PresentationFormat>Custom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nveer Ahmed</dc:creator>
  <cp:lastModifiedBy>Tanveer Ahmed</cp:lastModifiedBy>
  <cp:revision>29</cp:revision>
  <dcterms:created xsi:type="dcterms:W3CDTF">2022-03-20T05:55:51Z</dcterms:created>
  <dcterms:modified xsi:type="dcterms:W3CDTF">2022-09-10T08:02:06Z</dcterms:modified>
</cp:coreProperties>
</file>